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6"/>
  </p:notesMasterIdLst>
  <p:sldIdLst>
    <p:sldId id="258" r:id="rId5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091F07E-2E9B-42C1-AC31-E8F44A4987BC}" v="75" dt="2020-08-05T21:03:06.72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13" d="100"/>
          <a:sy n="113" d="100"/>
        </p:scale>
        <p:origin x="4122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ao, Xiugong" userId="982eadb4-bc94-434f-a8f5-f3e5c8a00808" providerId="ADAL" clId="{6091F07E-2E9B-42C1-AC31-E8F44A4987BC}"/>
    <pc:docChg chg="undo custSel delSld modSld">
      <pc:chgData name="Gao, Xiugong" userId="982eadb4-bc94-434f-a8f5-f3e5c8a00808" providerId="ADAL" clId="{6091F07E-2E9B-42C1-AC31-E8F44A4987BC}" dt="2020-08-05T21:03:33.019" v="646" actId="20577"/>
      <pc:docMkLst>
        <pc:docMk/>
      </pc:docMkLst>
      <pc:sldChg chg="delSp del">
        <pc:chgData name="Gao, Xiugong" userId="982eadb4-bc94-434f-a8f5-f3e5c8a00808" providerId="ADAL" clId="{6091F07E-2E9B-42C1-AC31-E8F44A4987BC}" dt="2020-08-05T18:39:13.659" v="127" actId="2696"/>
        <pc:sldMkLst>
          <pc:docMk/>
          <pc:sldMk cId="2376845397" sldId="256"/>
        </pc:sldMkLst>
        <pc:spChg chg="del">
          <ac:chgData name="Gao, Xiugong" userId="982eadb4-bc94-434f-a8f5-f3e5c8a00808" providerId="ADAL" clId="{6091F07E-2E9B-42C1-AC31-E8F44A4987BC}" dt="2020-08-05T18:36:14.375" v="93"/>
          <ac:spMkLst>
            <pc:docMk/>
            <pc:sldMk cId="2376845397" sldId="256"/>
            <ac:spMk id="24" creationId="{6CC48719-7A95-4EB8-A43B-076F0C427D3D}"/>
          </ac:spMkLst>
        </pc:spChg>
        <pc:grpChg chg="del">
          <ac:chgData name="Gao, Xiugong" userId="982eadb4-bc94-434f-a8f5-f3e5c8a00808" providerId="ADAL" clId="{6091F07E-2E9B-42C1-AC31-E8F44A4987BC}" dt="2020-08-05T18:25:17.603" v="1"/>
          <ac:grpSpMkLst>
            <pc:docMk/>
            <pc:sldMk cId="2376845397" sldId="256"/>
            <ac:grpSpMk id="10" creationId="{B574C5FD-66E4-4332-9ABD-FCD58E76B578}"/>
          </ac:grpSpMkLst>
        </pc:grpChg>
      </pc:sldChg>
      <pc:sldChg chg="addSp delSp modSp">
        <pc:chgData name="Gao, Xiugong" userId="982eadb4-bc94-434f-a8f5-f3e5c8a00808" providerId="ADAL" clId="{6091F07E-2E9B-42C1-AC31-E8F44A4987BC}" dt="2020-08-05T21:03:33.019" v="646" actId="20577"/>
        <pc:sldMkLst>
          <pc:docMk/>
          <pc:sldMk cId="1480391734" sldId="258"/>
        </pc:sldMkLst>
        <pc:spChg chg="mod">
          <ac:chgData name="Gao, Xiugong" userId="982eadb4-bc94-434f-a8f5-f3e5c8a00808" providerId="ADAL" clId="{6091F07E-2E9B-42C1-AC31-E8F44A4987BC}" dt="2020-08-05T18:35:21.592" v="58" actId="164"/>
          <ac:spMkLst>
            <pc:docMk/>
            <pc:sldMk cId="1480391734" sldId="258"/>
            <ac:spMk id="32" creationId="{1E6768B3-7D12-4BCE-B035-C6E8CEC88E52}"/>
          </ac:spMkLst>
        </pc:spChg>
        <pc:spChg chg="mod">
          <ac:chgData name="Gao, Xiugong" userId="982eadb4-bc94-434f-a8f5-f3e5c8a00808" providerId="ADAL" clId="{6091F07E-2E9B-42C1-AC31-E8F44A4987BC}" dt="2020-08-05T18:35:12.824" v="57" actId="164"/>
          <ac:spMkLst>
            <pc:docMk/>
            <pc:sldMk cId="1480391734" sldId="258"/>
            <ac:spMk id="38" creationId="{C34C574B-B0F7-4DC3-8FDE-35A5B929F7A0}"/>
          </ac:spMkLst>
        </pc:spChg>
        <pc:spChg chg="add mod">
          <ac:chgData name="Gao, Xiugong" userId="982eadb4-bc94-434f-a8f5-f3e5c8a00808" providerId="ADAL" clId="{6091F07E-2E9B-42C1-AC31-E8F44A4987BC}" dt="2020-08-05T21:03:33.019" v="646" actId="20577"/>
          <ac:spMkLst>
            <pc:docMk/>
            <pc:sldMk cId="1480391734" sldId="258"/>
            <ac:spMk id="64" creationId="{D7F35BF5-FA5C-4F7A-8FAC-E058DB5AD5B3}"/>
          </ac:spMkLst>
        </pc:spChg>
        <pc:grpChg chg="add mod">
          <ac:chgData name="Gao, Xiugong" userId="982eadb4-bc94-434f-a8f5-f3e5c8a00808" providerId="ADAL" clId="{6091F07E-2E9B-42C1-AC31-E8F44A4987BC}" dt="2020-08-05T18:42:01.083" v="171" actId="1076"/>
          <ac:grpSpMkLst>
            <pc:docMk/>
            <pc:sldMk cId="1480391734" sldId="258"/>
            <ac:grpSpMk id="31" creationId="{1FABD57A-03D9-4E81-A6BC-B0573871E223}"/>
          </ac:grpSpMkLst>
        </pc:grpChg>
        <pc:grpChg chg="del">
          <ac:chgData name="Gao, Xiugong" userId="982eadb4-bc94-434f-a8f5-f3e5c8a00808" providerId="ADAL" clId="{6091F07E-2E9B-42C1-AC31-E8F44A4987BC}" dt="2020-08-05T18:25:08.241" v="0" actId="478"/>
          <ac:grpSpMkLst>
            <pc:docMk/>
            <pc:sldMk cId="1480391734" sldId="258"/>
            <ac:grpSpMk id="33" creationId="{7F6C2A5E-8B49-4798-8442-B15B4FB67625}"/>
          </ac:grpSpMkLst>
        </pc:grpChg>
        <pc:grpChg chg="add mod">
          <ac:chgData name="Gao, Xiugong" userId="982eadb4-bc94-434f-a8f5-f3e5c8a00808" providerId="ADAL" clId="{6091F07E-2E9B-42C1-AC31-E8F44A4987BC}" dt="2020-08-05T18:35:50.881" v="91" actId="164"/>
          <ac:grpSpMkLst>
            <pc:docMk/>
            <pc:sldMk cId="1480391734" sldId="258"/>
            <ac:grpSpMk id="35" creationId="{081D3D0C-1E71-49B5-8C11-55BF58AE0083}"/>
          </ac:grpSpMkLst>
        </pc:grpChg>
        <pc:grpChg chg="add mod">
          <ac:chgData name="Gao, Xiugong" userId="982eadb4-bc94-434f-a8f5-f3e5c8a00808" providerId="ADAL" clId="{6091F07E-2E9B-42C1-AC31-E8F44A4987BC}" dt="2020-08-05T18:35:21.592" v="58" actId="164"/>
          <ac:grpSpMkLst>
            <pc:docMk/>
            <pc:sldMk cId="1480391734" sldId="258"/>
            <ac:grpSpMk id="43" creationId="{A8B45CED-5823-473F-9E38-5A5D110E47C8}"/>
          </ac:grpSpMkLst>
        </pc:grpChg>
        <pc:grpChg chg="add mod">
          <ac:chgData name="Gao, Xiugong" userId="982eadb4-bc94-434f-a8f5-f3e5c8a00808" providerId="ADAL" clId="{6091F07E-2E9B-42C1-AC31-E8F44A4987BC}" dt="2020-08-05T18:56:01.696" v="399" actId="164"/>
          <ac:grpSpMkLst>
            <pc:docMk/>
            <pc:sldMk cId="1480391734" sldId="258"/>
            <ac:grpSpMk id="63" creationId="{E6D5C5C9-C7B7-4B21-B998-8C4C6DA6F512}"/>
          </ac:grpSpMkLst>
        </pc:grpChg>
        <pc:grpChg chg="add mod">
          <ac:chgData name="Gao, Xiugong" userId="982eadb4-bc94-434f-a8f5-f3e5c8a00808" providerId="ADAL" clId="{6091F07E-2E9B-42C1-AC31-E8F44A4987BC}" dt="2020-08-05T20:25:53.995" v="606" actId="1076"/>
          <ac:grpSpMkLst>
            <pc:docMk/>
            <pc:sldMk cId="1480391734" sldId="258"/>
            <ac:grpSpMk id="65" creationId="{A46B0E07-F52D-4C90-9FB6-670D62326EEA}"/>
          </ac:grpSpMkLst>
        </pc:grpChg>
        <pc:graphicFrameChg chg="mod">
          <ac:chgData name="Gao, Xiugong" userId="982eadb4-bc94-434f-a8f5-f3e5c8a00808" providerId="ADAL" clId="{6091F07E-2E9B-42C1-AC31-E8F44A4987BC}" dt="2020-08-05T21:03:06.720" v="629"/>
          <ac:graphicFrameMkLst>
            <pc:docMk/>
            <pc:sldMk cId="1480391734" sldId="258"/>
            <ac:graphicFrameMk id="36" creationId="{3F0903EF-1775-43A5-8D74-93A3BBE3B5E1}"/>
          </ac:graphicFrameMkLst>
        </pc:graphicFrame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Rong.Li\Desktop\AFP%20and%20ALB%20(Takara%20and%20SM)%20for%20Xiugong's%20MS\000%20ALB%20and%20AFP%20comparison%20(to%20Xiugong)%20-%20updated\Quantification_ALB%20and%20AFP%20staining%20of%20HLC_SM%20and%20HLC_GF%2008032020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535858205216924"/>
          <c:y val="0.16956164517247882"/>
          <c:w val="0.80920408457814463"/>
          <c:h val="0.73063815252411091"/>
        </c:manualLayout>
      </c:layout>
      <c:barChart>
        <c:barDir val="col"/>
        <c:grouping val="clustered"/>
        <c:varyColors val="0"/>
        <c:ser>
          <c:idx val="0"/>
          <c:order val="0"/>
          <c:tx>
            <c:v>HLC_SM</c:v>
          </c:tx>
          <c:spPr>
            <a:solidFill>
              <a:schemeClr val="accent1">
                <a:lumMod val="7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heet1!$G$11,Sheet1!$K$11)</c:f>
                <c:numCache>
                  <c:formatCode>General</c:formatCode>
                  <c:ptCount val="2"/>
                  <c:pt idx="0">
                    <c:v>4.2164962152637271</c:v>
                  </c:pt>
                  <c:pt idx="1">
                    <c:v>6.4580693967573062</c:v>
                  </c:pt>
                </c:numCache>
              </c:numRef>
            </c:plus>
            <c:minus>
              <c:numRef>
                <c:f>(Sheet1!$G$11,Sheet1!$K$11)</c:f>
                <c:numCache>
                  <c:formatCode>General</c:formatCode>
                  <c:ptCount val="2"/>
                  <c:pt idx="0">
                    <c:v>4.2164962152637271</c:v>
                  </c:pt>
                  <c:pt idx="1">
                    <c:v>6.4580693967573062</c:v>
                  </c:pt>
                </c:numCache>
              </c:numRef>
            </c:minus>
          </c:errBars>
          <c:cat>
            <c:strRef>
              <c:f>(Sheet1!$F$6,Sheet1!$J$6)</c:f>
              <c:strCache>
                <c:ptCount val="2"/>
                <c:pt idx="0">
                  <c:v>ALB</c:v>
                </c:pt>
                <c:pt idx="1">
                  <c:v>AFP</c:v>
                </c:pt>
              </c:strCache>
            </c:strRef>
          </c:cat>
          <c:val>
            <c:numRef>
              <c:f>(Sheet1!$G$10,Sheet1!$K$10)</c:f>
              <c:numCache>
                <c:formatCode>0.000</c:formatCode>
                <c:ptCount val="2"/>
                <c:pt idx="0">
                  <c:v>13.151333333333334</c:v>
                </c:pt>
                <c:pt idx="1">
                  <c:v>13.6093333333333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819-4C25-BF8A-FC10866FA0BA}"/>
            </c:ext>
          </c:extLst>
        </c:ser>
        <c:ser>
          <c:idx val="1"/>
          <c:order val="1"/>
          <c:tx>
            <c:v>HLC_GF</c:v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heet1!$H$11,Sheet1!$L$11)</c:f>
                <c:numCache>
                  <c:formatCode>General</c:formatCode>
                  <c:ptCount val="2"/>
                  <c:pt idx="0">
                    <c:v>1.3009198028062032</c:v>
                  </c:pt>
                  <c:pt idx="1">
                    <c:v>0.95873997169896552</c:v>
                  </c:pt>
                </c:numCache>
              </c:numRef>
            </c:plus>
            <c:minus>
              <c:numRef>
                <c:f>(Sheet1!$H$11,Sheet1!$L$11)</c:f>
                <c:numCache>
                  <c:formatCode>General</c:formatCode>
                  <c:ptCount val="2"/>
                  <c:pt idx="0">
                    <c:v>1.3009198028062032</c:v>
                  </c:pt>
                  <c:pt idx="1">
                    <c:v>0.95873997169896552</c:v>
                  </c:pt>
                </c:numCache>
              </c:numRef>
            </c:minus>
          </c:errBars>
          <c:cat>
            <c:strRef>
              <c:f>(Sheet1!$F$6,Sheet1!$J$6)</c:f>
              <c:strCache>
                <c:ptCount val="2"/>
                <c:pt idx="0">
                  <c:v>ALB</c:v>
                </c:pt>
                <c:pt idx="1">
                  <c:v>AFP</c:v>
                </c:pt>
              </c:strCache>
            </c:strRef>
          </c:cat>
          <c:val>
            <c:numRef>
              <c:f>(Sheet1!$H$10,Sheet1!$L$10)</c:f>
              <c:numCache>
                <c:formatCode>0.000</c:formatCode>
                <c:ptCount val="2"/>
                <c:pt idx="0">
                  <c:v>20.122666666666664</c:v>
                </c:pt>
                <c:pt idx="1">
                  <c:v>20.3246666666666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819-4C25-BF8A-FC10866FA0B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91578352"/>
        <c:axId val="891579992"/>
      </c:barChart>
      <c:catAx>
        <c:axId val="8915783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91579992"/>
        <c:crosses val="autoZero"/>
        <c:auto val="1"/>
        <c:lblAlgn val="ctr"/>
        <c:lblOffset val="100"/>
        <c:noMultiLvlLbl val="0"/>
      </c:catAx>
      <c:valAx>
        <c:axId val="891579992"/>
        <c:scaling>
          <c:orientation val="minMax"/>
          <c:max val="25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00" b="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ean Fluorescence</a:t>
                </a:r>
                <a:r>
                  <a:rPr lang="en-US" sz="1000" b="0" baseline="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Intensity (AU)</a:t>
                </a:r>
                <a:endParaRPr lang="en-US" sz="1000" b="0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1.3980720533794838E-2"/>
              <c:y val="0.17407047124945957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0.0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91578352"/>
        <c:crosses val="autoZero"/>
        <c:crossBetween val="between"/>
        <c:majorUnit val="5"/>
      </c:valAx>
    </c:plotArea>
    <c:legend>
      <c:legendPos val="r"/>
      <c:layout>
        <c:manualLayout>
          <c:xMode val="edge"/>
          <c:yMode val="edge"/>
          <c:x val="0.81226820912338082"/>
          <c:y val="1.6213055411655842E-2"/>
          <c:w val="0.17373622047244094"/>
          <c:h val="0.1736300472168605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  <c:extLst/>
  </c:chart>
  <c:spPr>
    <a:ln>
      <a:noFill/>
    </a:ln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2A19F46-852C-4F22-947A-9150BE0FA7F9}" type="datetimeFigureOut">
              <a:rPr lang="en-US" smtClean="0"/>
              <a:t>8/5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963756C-2F7F-4FBB-A126-6A0692EFB1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78319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963756C-2F7F-4FBB-A126-6A0692EFB10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63211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045F35-3DCC-4C57-9D2F-487F49E1D9E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496484"/>
            <a:ext cx="51435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7EB4F8E-98D7-4004-A024-23B191855FA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D73046-E4AE-46AF-BEE0-D7E7028FAE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2E874D-C0FC-4F6A-96E5-6B6BFFF3F51B}" type="datetimeFigureOut">
              <a:rPr lang="en-US" smtClean="0"/>
              <a:t>8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9DD496-4585-451A-A699-575AA0555F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01A565-1B7B-4486-97FC-4FBDE3CA39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5910D8-2EB8-4833-A00D-53A123FF6A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35864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A50F5E-B424-4698-9F57-E48F8CD1EC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F4548E6-D630-43FE-B7DB-AACF1F3547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4FC37F-A528-47AA-A8D5-433F9AD268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2E874D-C0FC-4F6A-96E5-6B6BFFF3F51B}" type="datetimeFigureOut">
              <a:rPr lang="en-US" smtClean="0"/>
              <a:t>8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9DA3EA-2931-4A1C-93B2-B68B467E28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59C152-AF49-4FB9-A41D-04A5B8E680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5910D8-2EB8-4833-A00D-53A123FF6A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80210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D8DEE35-55DA-4620-AE88-B1E6DF1B2CF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CF56B6F-73E7-4F23-9178-35634AFE540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F1C1E2-26B4-4350-95AB-8AC40860C6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2E874D-C0FC-4F6A-96E5-6B6BFFF3F51B}" type="datetimeFigureOut">
              <a:rPr lang="en-US" smtClean="0"/>
              <a:t>8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7D7355-BA20-41E4-A9EA-2905FA77A5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D89A23-1B27-4092-B5CB-45E170CD35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5910D8-2EB8-4833-A00D-53A123FF6A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49280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CA6259-78B4-452B-AD65-BEF84D96A2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55D9716-41C7-48B6-9DC3-5187BE9BFD9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BBBF27-2427-49BC-9125-D96FA4B383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2E874D-C0FC-4F6A-96E5-6B6BFFF3F51B}" type="datetimeFigureOut">
              <a:rPr lang="en-US" smtClean="0"/>
              <a:t>8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3A831D-78C6-447E-AB2E-AA3E045862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B2C5BF-394D-4C52-9354-E1D39A8C23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5910D8-2EB8-4833-A00D-53A123FF6A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38588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64C8EA-1FE4-4425-949C-CCACF82027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279652"/>
            <a:ext cx="5915025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ADE8CB9-D5DB-45B7-8B0D-274B69FFAE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119285"/>
            <a:ext cx="5915025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1D403D-5AFF-4999-80C7-89D2F9C206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2E874D-C0FC-4F6A-96E5-6B6BFFF3F51B}" type="datetimeFigureOut">
              <a:rPr lang="en-US" smtClean="0"/>
              <a:t>8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8D2126-B97E-4ABF-A1F1-001A2F3D4E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D4D13D-D9B4-4027-ADC4-F9AB78C023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5910D8-2EB8-4833-A00D-53A123FF6A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71684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FB8533-A141-4DCA-8F28-961860BC19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43A966A-E37A-44CF-8626-4935B1D3169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5C49C1B-893F-46B3-8A11-2F005220960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0637826-78D9-4644-A544-FE0924F7DF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2E874D-C0FC-4F6A-96E5-6B6BFFF3F51B}" type="datetimeFigureOut">
              <a:rPr lang="en-US" smtClean="0"/>
              <a:t>8/5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65499C0-11EA-407A-9ED5-D5C7D78892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FDD5109-F08F-4522-B4CA-378A15C973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5910D8-2EB8-4833-A00D-53A123FF6A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21705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DA7C11-FDD9-4688-B6C6-7C4E4A708F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486834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DB94BD9-4662-47DC-B80C-1C49128BA2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4F56228-932B-446D-B7C7-32DEBCF486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97DBA5A-1A50-4247-818E-ABA78145D58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E76DE5F-3C37-475E-9E9D-F05B734F3C3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733FD97-958B-4817-94F3-0F1423C905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2E874D-C0FC-4F6A-96E5-6B6BFFF3F51B}" type="datetimeFigureOut">
              <a:rPr lang="en-US" smtClean="0"/>
              <a:t>8/5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CB3FF77-A3B6-4C37-A4C1-AA3E41E4A3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B5D467E-7A81-44D4-A380-774AEE6AD7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5910D8-2EB8-4833-A00D-53A123FF6A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88221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4457EB-6826-4B62-8930-C3D73DA185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7094BE7-647F-4675-865D-E6CAEFD6AF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2E874D-C0FC-4F6A-96E5-6B6BFFF3F51B}" type="datetimeFigureOut">
              <a:rPr lang="en-US" smtClean="0"/>
              <a:t>8/5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91D2AD8-70D5-46F1-93E9-5A6D150338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13FE25A-AF00-4D15-B732-E3D836889C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5910D8-2EB8-4833-A00D-53A123FF6A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48171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8AAEFA6-CD92-4A43-A30E-8A2B31E6DE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2E874D-C0FC-4F6A-96E5-6B6BFFF3F51B}" type="datetimeFigureOut">
              <a:rPr lang="en-US" smtClean="0"/>
              <a:t>8/5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9BCEADA-00D5-46D5-9A71-47C698EEA3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0D11916-2A45-4B3E-B597-85D9753340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5910D8-2EB8-4833-A00D-53A123FF6A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44979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527114-CA32-4883-9509-7951E69491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D63D91A-B20C-4200-BF50-08BC04502B1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0411A7D-3C0E-4E3A-82B6-E046240DF86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70D3154-7EC4-429F-B26D-F75E557252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2E874D-C0FC-4F6A-96E5-6B6BFFF3F51B}" type="datetimeFigureOut">
              <a:rPr lang="en-US" smtClean="0"/>
              <a:t>8/5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2277D81-798C-4DA4-A77E-B79BFE62E4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C8E1204-72B9-422D-97B6-1612C080E2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5910D8-2EB8-4833-A00D-53A123FF6A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9266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FA19D9-1014-4BB1-A3C8-810737C5D9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E2FE6C7-765F-4699-8BD4-C509C974EB2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77C5BFA-4499-447B-BB14-F4928086448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21C4358-3AA8-43C0-A8E0-F18CC404EC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2E874D-C0FC-4F6A-96E5-6B6BFFF3F51B}" type="datetimeFigureOut">
              <a:rPr lang="en-US" smtClean="0"/>
              <a:t>8/5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952CF18-02B9-4053-8A8F-8A9CC8128D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E9ADCBF-694B-464C-9FDC-C6F1C18C2C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5910D8-2EB8-4833-A00D-53A123FF6A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9060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F708710-E86D-4BCA-BE24-F29FDE8168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486834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775C46D-2765-4659-909A-15A364D56F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30D651-992C-41CE-9362-A463D839B89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2E874D-C0FC-4F6A-96E5-6B6BFFF3F51B}" type="datetimeFigureOut">
              <a:rPr lang="en-US" smtClean="0"/>
              <a:t>8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F940BA-73ED-458B-BAE2-46AA3BCAAA2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8475134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6A2FB7-11FE-43DB-A1EC-3CC5203920A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5910D8-2EB8-4833-A00D-53A123FF6A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53223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13" Type="http://schemas.microsoft.com/office/2007/relationships/hdphoto" Target="../media/hdphoto5.wdp"/><Relationship Id="rId18" Type="http://schemas.openxmlformats.org/officeDocument/2006/relationships/image" Target="../media/image8.png"/><Relationship Id="rId3" Type="http://schemas.openxmlformats.org/officeDocument/2006/relationships/chart" Target="../charts/chart1.xml"/><Relationship Id="rId7" Type="http://schemas.microsoft.com/office/2007/relationships/hdphoto" Target="../media/hdphoto2.wdp"/><Relationship Id="rId12" Type="http://schemas.openxmlformats.org/officeDocument/2006/relationships/image" Target="../media/image5.png"/><Relationship Id="rId17" Type="http://schemas.microsoft.com/office/2007/relationships/hdphoto" Target="../media/hdphoto7.wdp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.png"/><Relationship Id="rId11" Type="http://schemas.microsoft.com/office/2007/relationships/hdphoto" Target="../media/hdphoto4.wdp"/><Relationship Id="rId5" Type="http://schemas.microsoft.com/office/2007/relationships/hdphoto" Target="../media/hdphoto1.wdp"/><Relationship Id="rId15" Type="http://schemas.microsoft.com/office/2007/relationships/hdphoto" Target="../media/hdphoto6.wdp"/><Relationship Id="rId10" Type="http://schemas.openxmlformats.org/officeDocument/2006/relationships/image" Target="../media/image4.png"/><Relationship Id="rId4" Type="http://schemas.openxmlformats.org/officeDocument/2006/relationships/image" Target="../media/image1.png"/><Relationship Id="rId9" Type="http://schemas.microsoft.com/office/2007/relationships/hdphoto" Target="../media/hdphoto3.wdp"/><Relationship Id="rId1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5" name="Group 64">
            <a:extLst>
              <a:ext uri="{FF2B5EF4-FFF2-40B4-BE49-F238E27FC236}">
                <a16:creationId xmlns:a16="http://schemas.microsoft.com/office/drawing/2014/main" id="{A46B0E07-F52D-4C90-9FB6-670D62326EEA}"/>
              </a:ext>
            </a:extLst>
          </p:cNvPr>
          <p:cNvGrpSpPr/>
          <p:nvPr/>
        </p:nvGrpSpPr>
        <p:grpSpPr>
          <a:xfrm>
            <a:off x="731520" y="936757"/>
            <a:ext cx="5394960" cy="7270486"/>
            <a:chOff x="758848" y="1310021"/>
            <a:chExt cx="5394960" cy="7270486"/>
          </a:xfrm>
        </p:grpSpPr>
        <p:grpSp>
          <p:nvGrpSpPr>
            <p:cNvPr id="63" name="Group 62">
              <a:extLst>
                <a:ext uri="{FF2B5EF4-FFF2-40B4-BE49-F238E27FC236}">
                  <a16:creationId xmlns:a16="http://schemas.microsoft.com/office/drawing/2014/main" id="{E6D5C5C9-C7B7-4B21-B998-8C4C6DA6F512}"/>
                </a:ext>
              </a:extLst>
            </p:cNvPr>
            <p:cNvGrpSpPr/>
            <p:nvPr/>
          </p:nvGrpSpPr>
          <p:grpSpPr>
            <a:xfrm>
              <a:off x="808062" y="1310021"/>
              <a:ext cx="5241875" cy="5542659"/>
              <a:chOff x="754417" y="708791"/>
              <a:chExt cx="5241875" cy="5542659"/>
            </a:xfrm>
          </p:grpSpPr>
          <p:grpSp>
            <p:nvGrpSpPr>
              <p:cNvPr id="31" name="Group 30">
                <a:extLst>
                  <a:ext uri="{FF2B5EF4-FFF2-40B4-BE49-F238E27FC236}">
                    <a16:creationId xmlns:a16="http://schemas.microsoft.com/office/drawing/2014/main" id="{1FABD57A-03D9-4E81-A6BC-B0573871E223}"/>
                  </a:ext>
                </a:extLst>
              </p:cNvPr>
              <p:cNvGrpSpPr/>
              <p:nvPr/>
            </p:nvGrpSpPr>
            <p:grpSpPr>
              <a:xfrm>
                <a:off x="754417" y="3562888"/>
                <a:ext cx="5241875" cy="2688562"/>
                <a:chOff x="754417" y="4135912"/>
                <a:chExt cx="5241875" cy="2688562"/>
              </a:xfrm>
            </p:grpSpPr>
            <p:graphicFrame>
              <p:nvGraphicFramePr>
                <p:cNvPr id="36" name="Chart 35">
                  <a:extLst>
                    <a:ext uri="{FF2B5EF4-FFF2-40B4-BE49-F238E27FC236}">
                      <a16:creationId xmlns:a16="http://schemas.microsoft.com/office/drawing/2014/main" id="{3F0903EF-1775-43A5-8D74-93A3BBE3B5E1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879282016"/>
                    </p:ext>
                  </p:extLst>
                </p:nvPr>
              </p:nvGraphicFramePr>
              <p:xfrm>
                <a:off x="976236" y="4474466"/>
                <a:ext cx="5020056" cy="2350008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sp>
              <p:nvSpPr>
                <p:cNvPr id="38" name="TextBox 37">
                  <a:extLst>
                    <a:ext uri="{FF2B5EF4-FFF2-40B4-BE49-F238E27FC236}">
                      <a16:creationId xmlns:a16="http://schemas.microsoft.com/office/drawing/2014/main" id="{C34C574B-B0F7-4DC3-8FDE-35A5B929F7A0}"/>
                    </a:ext>
                  </a:extLst>
                </p:cNvPr>
                <p:cNvSpPr txBox="1"/>
                <p:nvPr/>
              </p:nvSpPr>
              <p:spPr>
                <a:xfrm>
                  <a:off x="754417" y="4135912"/>
                  <a:ext cx="332142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</a:t>
                  </a:r>
                </a:p>
              </p:txBody>
            </p:sp>
          </p:grpSp>
          <p:grpSp>
            <p:nvGrpSpPr>
              <p:cNvPr id="35" name="Group 34">
                <a:extLst>
                  <a:ext uri="{FF2B5EF4-FFF2-40B4-BE49-F238E27FC236}">
                    <a16:creationId xmlns:a16="http://schemas.microsoft.com/office/drawing/2014/main" id="{081D3D0C-1E71-49B5-8C11-55BF58AE0083}"/>
                  </a:ext>
                </a:extLst>
              </p:cNvPr>
              <p:cNvGrpSpPr/>
              <p:nvPr/>
            </p:nvGrpSpPr>
            <p:grpSpPr>
              <a:xfrm>
                <a:off x="754417" y="708791"/>
                <a:ext cx="5183095" cy="2692417"/>
                <a:chOff x="754417" y="708791"/>
                <a:chExt cx="5183095" cy="2692417"/>
              </a:xfrm>
            </p:grpSpPr>
            <p:sp>
              <p:nvSpPr>
                <p:cNvPr id="32" name="TextBox 31">
                  <a:extLst>
                    <a:ext uri="{FF2B5EF4-FFF2-40B4-BE49-F238E27FC236}">
                      <a16:creationId xmlns:a16="http://schemas.microsoft.com/office/drawing/2014/main" id="{1E6768B3-7D12-4BCE-B035-C6E8CEC88E52}"/>
                    </a:ext>
                  </a:extLst>
                </p:cNvPr>
                <p:cNvSpPr txBox="1"/>
                <p:nvPr/>
              </p:nvSpPr>
              <p:spPr>
                <a:xfrm>
                  <a:off x="754417" y="708791"/>
                  <a:ext cx="332142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</a:p>
              </p:txBody>
            </p:sp>
            <p:grpSp>
              <p:nvGrpSpPr>
                <p:cNvPr id="43" name="Group 42">
                  <a:extLst>
                    <a:ext uri="{FF2B5EF4-FFF2-40B4-BE49-F238E27FC236}">
                      <a16:creationId xmlns:a16="http://schemas.microsoft.com/office/drawing/2014/main" id="{A8B45CED-5823-473F-9E38-5A5D110E47C8}"/>
                    </a:ext>
                  </a:extLst>
                </p:cNvPr>
                <p:cNvGrpSpPr/>
                <p:nvPr/>
              </p:nvGrpSpPr>
              <p:grpSpPr>
                <a:xfrm>
                  <a:off x="920488" y="1047345"/>
                  <a:ext cx="5017024" cy="2353863"/>
                  <a:chOff x="928227" y="1060819"/>
                  <a:chExt cx="5017024" cy="2353863"/>
                </a:xfrm>
              </p:grpSpPr>
              <p:pic>
                <p:nvPicPr>
                  <p:cNvPr id="44" name="Picture 43">
                    <a:extLst>
                      <a:ext uri="{FF2B5EF4-FFF2-40B4-BE49-F238E27FC236}">
                        <a16:creationId xmlns:a16="http://schemas.microsoft.com/office/drawing/2014/main" id="{6B6B786C-B8F6-42DC-A8DB-0C58B4268672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4">
                    <a:extLst>
                      <a:ext uri="{BEBA8EAE-BF5A-486C-A8C5-ECC9F3942E4B}">
                        <a14:imgProps xmlns:a14="http://schemas.microsoft.com/office/drawing/2010/main">
                          <a14:imgLayer r:embed="rId5">
                            <a14:imgEffect>
                              <a14:brightnessContrast bright="4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4710573" y="1550040"/>
                    <a:ext cx="1219200" cy="914400"/>
                  </a:xfrm>
                  <a:prstGeom prst="rect">
                    <a:avLst/>
                  </a:prstGeom>
                </p:spPr>
              </p:pic>
              <p:pic>
                <p:nvPicPr>
                  <p:cNvPr id="45" name="Picture 44">
                    <a:extLst>
                      <a:ext uri="{FF2B5EF4-FFF2-40B4-BE49-F238E27FC236}">
                        <a16:creationId xmlns:a16="http://schemas.microsoft.com/office/drawing/2014/main" id="{BAE350CF-EBC9-44AD-83F2-06CCE3934D69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6">
                    <a:extLst>
                      <a:ext uri="{BEBA8EAE-BF5A-486C-A8C5-ECC9F3942E4B}">
                        <a14:imgProps xmlns:a14="http://schemas.microsoft.com/office/drawing/2010/main">
                          <a14:imgLayer r:embed="rId7">
                            <a14:imgEffect>
                              <a14:sharpenSoften amount="50000"/>
                            </a14:imgEffect>
                            <a14:imgEffect>
                              <a14:brightnessContrast bright="4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4710572" y="2500282"/>
                    <a:ext cx="1219200" cy="914400"/>
                  </a:xfrm>
                  <a:prstGeom prst="rect">
                    <a:avLst/>
                  </a:prstGeom>
                </p:spPr>
              </p:pic>
              <p:pic>
                <p:nvPicPr>
                  <p:cNvPr id="46" name="Picture 45">
                    <a:extLst>
                      <a:ext uri="{FF2B5EF4-FFF2-40B4-BE49-F238E27FC236}">
                        <a16:creationId xmlns:a16="http://schemas.microsoft.com/office/drawing/2014/main" id="{804F257E-4C8D-4DE2-A464-A4C81AB700F7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8">
                    <a:extLst>
                      <a:ext uri="{BEBA8EAE-BF5A-486C-A8C5-ECC9F3942E4B}">
                        <a14:imgProps xmlns:a14="http://schemas.microsoft.com/office/drawing/2010/main">
                          <a14:imgLayer r:embed="rId9">
                            <a14:imgEffect>
                              <a14:brightnessContrast bright="4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3449791" y="1550040"/>
                    <a:ext cx="1219200" cy="914400"/>
                  </a:xfrm>
                  <a:prstGeom prst="rect">
                    <a:avLst/>
                  </a:prstGeom>
                </p:spPr>
              </p:pic>
              <p:pic>
                <p:nvPicPr>
                  <p:cNvPr id="47" name="Picture 46">
                    <a:extLst>
                      <a:ext uri="{FF2B5EF4-FFF2-40B4-BE49-F238E27FC236}">
                        <a16:creationId xmlns:a16="http://schemas.microsoft.com/office/drawing/2014/main" id="{BD784083-AB88-4A1E-B627-0981DA9F706E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0">
                    <a:extLst>
                      <a:ext uri="{BEBA8EAE-BF5A-486C-A8C5-ECC9F3942E4B}">
                        <a14:imgProps xmlns:a14="http://schemas.microsoft.com/office/drawing/2010/main">
                          <a14:imgLayer r:embed="rId11">
                            <a14:imgEffect>
                              <a14:brightnessContrast bright="4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3449791" y="2500282"/>
                    <a:ext cx="1219200" cy="914400"/>
                  </a:xfrm>
                  <a:prstGeom prst="rect">
                    <a:avLst/>
                  </a:prstGeom>
                </p:spPr>
              </p:pic>
              <p:sp>
                <p:nvSpPr>
                  <p:cNvPr id="48" name="TextBox 47">
                    <a:extLst>
                      <a:ext uri="{FF2B5EF4-FFF2-40B4-BE49-F238E27FC236}">
                        <a16:creationId xmlns:a16="http://schemas.microsoft.com/office/drawing/2014/main" id="{B0884F3C-E908-4AD9-BD7A-087611D2831F}"/>
                      </a:ext>
                    </a:extLst>
                  </p:cNvPr>
                  <p:cNvSpPr txBox="1"/>
                  <p:nvPr/>
                </p:nvSpPr>
                <p:spPr>
                  <a:xfrm>
                    <a:off x="5073952" y="1341011"/>
                    <a:ext cx="409086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FP</a:t>
                    </a:r>
                  </a:p>
                </p:txBody>
              </p:sp>
              <p:sp>
                <p:nvSpPr>
                  <p:cNvPr id="49" name="TextBox 48">
                    <a:extLst>
                      <a:ext uri="{FF2B5EF4-FFF2-40B4-BE49-F238E27FC236}">
                        <a16:creationId xmlns:a16="http://schemas.microsoft.com/office/drawing/2014/main" id="{C695DD1A-176A-4A90-B341-D43BC3F58AED}"/>
                      </a:ext>
                    </a:extLst>
                  </p:cNvPr>
                  <p:cNvSpPr txBox="1"/>
                  <p:nvPr/>
                </p:nvSpPr>
                <p:spPr>
                  <a:xfrm>
                    <a:off x="3809163" y="1341011"/>
                    <a:ext cx="402674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LB</a:t>
                    </a:r>
                  </a:p>
                </p:txBody>
              </p:sp>
              <p:sp>
                <p:nvSpPr>
                  <p:cNvPr id="50" name="TextBox 49">
                    <a:extLst>
                      <a:ext uri="{FF2B5EF4-FFF2-40B4-BE49-F238E27FC236}">
                        <a16:creationId xmlns:a16="http://schemas.microsoft.com/office/drawing/2014/main" id="{A2C63189-767D-4002-B42A-873B3EA593DF}"/>
                      </a:ext>
                    </a:extLst>
                  </p:cNvPr>
                  <p:cNvSpPr txBox="1"/>
                  <p:nvPr/>
                </p:nvSpPr>
                <p:spPr>
                  <a:xfrm>
                    <a:off x="2552388" y="1341011"/>
                    <a:ext cx="409086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FP</a:t>
                    </a:r>
                  </a:p>
                </p:txBody>
              </p:sp>
              <p:pic>
                <p:nvPicPr>
                  <p:cNvPr id="51" name="Picture 50">
                    <a:extLst>
                      <a:ext uri="{FF2B5EF4-FFF2-40B4-BE49-F238E27FC236}">
                        <a16:creationId xmlns:a16="http://schemas.microsoft.com/office/drawing/2014/main" id="{BED2E174-98E2-4F5C-B497-8084DD877067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2">
                    <a:extLst>
                      <a:ext uri="{BEBA8EAE-BF5A-486C-A8C5-ECC9F3942E4B}">
                        <a14:imgProps xmlns:a14="http://schemas.microsoft.com/office/drawing/2010/main">
                          <a14:imgLayer r:embed="rId13">
                            <a14:imgEffect>
                              <a14:brightnessContrast bright="4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928227" y="1550040"/>
                    <a:ext cx="1219200" cy="914400"/>
                  </a:xfrm>
                  <a:prstGeom prst="rect">
                    <a:avLst/>
                  </a:prstGeom>
                </p:spPr>
              </p:pic>
              <p:pic>
                <p:nvPicPr>
                  <p:cNvPr id="52" name="Picture 51">
                    <a:extLst>
                      <a:ext uri="{FF2B5EF4-FFF2-40B4-BE49-F238E27FC236}">
                        <a16:creationId xmlns:a16="http://schemas.microsoft.com/office/drawing/2014/main" id="{9E89023D-2512-493C-B8A4-A05EFB83CD0D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4">
                    <a:extLst>
                      <a:ext uri="{BEBA8EAE-BF5A-486C-A8C5-ECC9F3942E4B}">
                        <a14:imgProps xmlns:a14="http://schemas.microsoft.com/office/drawing/2010/main">
                          <a14:imgLayer r:embed="rId15">
                            <a14:imgEffect>
                              <a14:brightnessContrast brigh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928227" y="2500282"/>
                    <a:ext cx="1219200" cy="914400"/>
                  </a:xfrm>
                  <a:prstGeom prst="rect">
                    <a:avLst/>
                  </a:prstGeom>
                </p:spPr>
              </p:pic>
              <p:sp>
                <p:nvSpPr>
                  <p:cNvPr id="53" name="TextBox 52">
                    <a:extLst>
                      <a:ext uri="{FF2B5EF4-FFF2-40B4-BE49-F238E27FC236}">
                        <a16:creationId xmlns:a16="http://schemas.microsoft.com/office/drawing/2014/main" id="{633931A9-5653-44C5-8E04-1F14DAEB5E4F}"/>
                      </a:ext>
                    </a:extLst>
                  </p:cNvPr>
                  <p:cNvSpPr txBox="1"/>
                  <p:nvPr/>
                </p:nvSpPr>
                <p:spPr>
                  <a:xfrm>
                    <a:off x="1287598" y="1341011"/>
                    <a:ext cx="402674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LB</a:t>
                    </a:r>
                  </a:p>
                </p:txBody>
              </p:sp>
              <p:sp>
                <p:nvSpPr>
                  <p:cNvPr id="54" name="TextBox 53">
                    <a:extLst>
                      <a:ext uri="{FF2B5EF4-FFF2-40B4-BE49-F238E27FC236}">
                        <a16:creationId xmlns:a16="http://schemas.microsoft.com/office/drawing/2014/main" id="{644BC997-0117-4E12-BB6F-366D297DF48E}"/>
                      </a:ext>
                    </a:extLst>
                  </p:cNvPr>
                  <p:cNvSpPr txBox="1"/>
                  <p:nvPr/>
                </p:nvSpPr>
                <p:spPr>
                  <a:xfrm>
                    <a:off x="4165829" y="1060819"/>
                    <a:ext cx="1053494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LC_GF (D23)</a:t>
                    </a:r>
                  </a:p>
                </p:txBody>
              </p:sp>
              <p:sp>
                <p:nvSpPr>
                  <p:cNvPr id="55" name="TextBox 54">
                    <a:extLst>
                      <a:ext uri="{FF2B5EF4-FFF2-40B4-BE49-F238E27FC236}">
                        <a16:creationId xmlns:a16="http://schemas.microsoft.com/office/drawing/2014/main" id="{2C95FAE0-0D4E-42F2-8F2C-2783552B9947}"/>
                      </a:ext>
                    </a:extLst>
                  </p:cNvPr>
                  <p:cNvSpPr txBox="1"/>
                  <p:nvPr/>
                </p:nvSpPr>
                <p:spPr>
                  <a:xfrm>
                    <a:off x="1632168" y="1060819"/>
                    <a:ext cx="1067921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LC_SM (D24)</a:t>
                    </a:r>
                  </a:p>
                </p:txBody>
              </p:sp>
              <p:cxnSp>
                <p:nvCxnSpPr>
                  <p:cNvPr id="56" name="Straight Connector 55">
                    <a:extLst>
                      <a:ext uri="{FF2B5EF4-FFF2-40B4-BE49-F238E27FC236}">
                        <a16:creationId xmlns:a16="http://schemas.microsoft.com/office/drawing/2014/main" id="{3A034523-E970-4DC9-AF79-824A08DE56F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967555" y="1314968"/>
                    <a:ext cx="2397147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7" name="Straight Connector 56">
                    <a:extLst>
                      <a:ext uri="{FF2B5EF4-FFF2-40B4-BE49-F238E27FC236}">
                        <a16:creationId xmlns:a16="http://schemas.microsoft.com/office/drawing/2014/main" id="{BC751963-BA8C-4260-80C8-8E25E00244C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494003" y="1314968"/>
                    <a:ext cx="2397147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58" name="Group 57">
                    <a:extLst>
                      <a:ext uri="{FF2B5EF4-FFF2-40B4-BE49-F238E27FC236}">
                        <a16:creationId xmlns:a16="http://schemas.microsoft.com/office/drawing/2014/main" id="{84F64EE5-53E6-4289-9820-9D2BE65A9445}"/>
                      </a:ext>
                    </a:extLst>
                  </p:cNvPr>
                  <p:cNvGrpSpPr/>
                  <p:nvPr/>
                </p:nvGrpSpPr>
                <p:grpSpPr>
                  <a:xfrm>
                    <a:off x="5496089" y="3158575"/>
                    <a:ext cx="449162" cy="184666"/>
                    <a:chOff x="5496089" y="3158575"/>
                    <a:chExt cx="449162" cy="184666"/>
                  </a:xfrm>
                </p:grpSpPr>
                <p:cxnSp>
                  <p:nvCxnSpPr>
                    <p:cNvPr id="61" name="Straight Connector 60">
                      <a:extLst>
                        <a:ext uri="{FF2B5EF4-FFF2-40B4-BE49-F238E27FC236}">
                          <a16:creationId xmlns:a16="http://schemas.microsoft.com/office/drawing/2014/main" id="{241ACB95-260F-4988-9396-D9A3558D7E79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5585995" y="3327477"/>
                      <a:ext cx="269351" cy="0"/>
                    </a:xfrm>
                    <a:prstGeom prst="line">
                      <a:avLst/>
                    </a:prstGeom>
                    <a:ln w="9525">
                      <a:solidFill>
                        <a:schemeClr val="bg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62" name="TextBox 61">
                      <a:extLst>
                        <a:ext uri="{FF2B5EF4-FFF2-40B4-BE49-F238E27FC236}">
                          <a16:creationId xmlns:a16="http://schemas.microsoft.com/office/drawing/2014/main" id="{B25C0DB5-DFC4-44EA-949A-904D46FD4C0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496089" y="3158575"/>
                      <a:ext cx="449162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60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0 </a:t>
                      </a:r>
                      <a:r>
                        <a:rPr lang="en-US" sz="60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Symbol" panose="05050102010706020507" pitchFamily="18" charset="2"/>
                        </a:rPr>
                        <a:t>m</a:t>
                      </a:r>
                      <a:endParaRPr lang="en-US" sz="6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pic>
                <p:nvPicPr>
                  <p:cNvPr id="59" name="Picture 58">
                    <a:extLst>
                      <a:ext uri="{FF2B5EF4-FFF2-40B4-BE49-F238E27FC236}">
                        <a16:creationId xmlns:a16="http://schemas.microsoft.com/office/drawing/2014/main" id="{8A088513-E31A-4F8A-A184-B424DB179627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6">
                    <a:extLst>
                      <a:ext uri="{BEBA8EAE-BF5A-486C-A8C5-ECC9F3942E4B}">
                        <a14:imgProps xmlns:a14="http://schemas.microsoft.com/office/drawing/2010/main">
                          <a14:imgLayer r:embed="rId17">
                            <a14:imgEffect>
                              <a14:brightnessContrast bright="4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2189009" y="1550040"/>
                    <a:ext cx="1219200" cy="914400"/>
                  </a:xfrm>
                  <a:prstGeom prst="rect">
                    <a:avLst/>
                  </a:prstGeom>
                </p:spPr>
              </p:pic>
              <p:pic>
                <p:nvPicPr>
                  <p:cNvPr id="60" name="Picture 59">
                    <a:extLst>
                      <a:ext uri="{FF2B5EF4-FFF2-40B4-BE49-F238E27FC236}">
                        <a16:creationId xmlns:a16="http://schemas.microsoft.com/office/drawing/2014/main" id="{4DDF6299-F930-4AA6-95A6-083755CA4652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8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2189009" y="2500282"/>
                    <a:ext cx="1219200" cy="914400"/>
                  </a:xfrm>
                  <a:prstGeom prst="rect">
                    <a:avLst/>
                  </a:prstGeom>
                </p:spPr>
              </p:pic>
            </p:grpSp>
          </p:grpSp>
        </p:grp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D7F35BF5-FA5C-4F7A-8FAC-E058DB5AD5B3}"/>
                </a:ext>
              </a:extLst>
            </p:cNvPr>
            <p:cNvSpPr txBox="1"/>
            <p:nvPr/>
          </p:nvSpPr>
          <p:spPr>
            <a:xfrm>
              <a:off x="758848" y="7195512"/>
              <a:ext cx="5394960" cy="1384995"/>
            </a:xfrm>
            <a:prstGeom prst="rect">
              <a:avLst/>
            </a:prstGeom>
            <a:noFill/>
          </p:spPr>
          <p:txBody>
            <a:bodyPr wrap="square" lIns="0" rIns="0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l Figure 1.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mparison of albumin (ALB) and alpha-fetoprotein (AFP) expression between HLC_SM and HLC_GF. (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Representative immunocytochemistry images demonstrating the expression of ALB and AFP at the final stage of hepatocyte differentiation. Scale bar, 400 μm. (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Bar graph showing mean fluorescence intensity (arbitrary unit) of ALB and AFP calculated from three images (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= 3) using the ImageJ software. Error bars represent standard deviation (SD). No statistically significant (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&lt; 0.05) differences were found between the two cell types for either ALB or AFP.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4803917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76A08FBD5310342BF958ADCB470BE9A" ma:contentTypeVersion="7" ma:contentTypeDescription="Create a new document." ma:contentTypeScope="" ma:versionID="72fa52eb8ad471e6cad3c4758bbc4c89">
  <xsd:schema xmlns:xsd="http://www.w3.org/2001/XMLSchema" xmlns:xs="http://www.w3.org/2001/XMLSchema" xmlns:p="http://schemas.microsoft.com/office/2006/metadata/properties" xmlns:ns3="978cbee1-b604-4d95-9f89-3d25ff6383a8" targetNamespace="http://schemas.microsoft.com/office/2006/metadata/properties" ma:root="true" ma:fieldsID="c9afe7279023c5d82bec6d0fd5a236e8" ns3:_="">
    <xsd:import namespace="978cbee1-b604-4d95-9f89-3d25ff6383a8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78cbee1-b604-4d95-9f89-3d25ff6383a8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1" nillable="true" ma:displayName="Tags" ma:internalName="MediaServiceAutoTags" ma:readOnly="true">
      <xsd:simpleType>
        <xsd:restriction base="dms:Text"/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47446CA9-CB04-4880-AFD4-9ACCF3510B3E}">
  <ds:schemaRefs>
    <ds:schemaRef ds:uri="http://schemas.microsoft.com/office/2006/metadata/properties"/>
    <ds:schemaRef ds:uri="http://schemas.microsoft.com/office/infopath/2007/PartnerControls"/>
  </ds:schemaRefs>
</ds:datastoreItem>
</file>

<file path=customXml/itemProps2.xml><?xml version="1.0" encoding="utf-8"?>
<ds:datastoreItem xmlns:ds="http://schemas.openxmlformats.org/officeDocument/2006/customXml" ds:itemID="{63ED7A6F-884F-49E1-AC84-248AA59CD1C2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D37291D5-E7CE-4073-A786-0F87D5807E6F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978cbee1-b604-4d95-9f89-3d25ff6383a8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257</TotalTime>
  <Words>141</Words>
  <Application>Microsoft Office PowerPoint</Application>
  <PresentationFormat>Letter Paper (8.5x11 in)</PresentationFormat>
  <Paragraphs>1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, Rong</dc:creator>
  <cp:lastModifiedBy>Gao, Xiugong</cp:lastModifiedBy>
  <cp:revision>30</cp:revision>
  <dcterms:created xsi:type="dcterms:W3CDTF">2020-07-30T18:12:45Z</dcterms:created>
  <dcterms:modified xsi:type="dcterms:W3CDTF">2020-08-05T21:03:3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76A08FBD5310342BF958ADCB470BE9A</vt:lpwstr>
  </property>
</Properties>
</file>